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 smtClean="0"/>
              <a:t>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779597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39334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8394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5457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1270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1925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08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27877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87223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64538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197F0B-8B66-4C54-91FD-95BDA12FA3AF}" type="datetimeFigureOut">
              <a:rPr lang="fr-FR" smtClean="0"/>
              <a:t>10/10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561CB-7B2B-4C4F-8218-E827804CB96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00011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561107" y="287310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 smtClean="0"/>
              <a:t>A</a:t>
            </a:r>
            <a:endParaRPr lang="fr-FR" b="1" dirty="0"/>
          </a:p>
        </p:txBody>
      </p:sp>
      <p:sp>
        <p:nvSpPr>
          <p:cNvPr id="9" name="ZoneTexte 8"/>
          <p:cNvSpPr txBox="1"/>
          <p:nvPr/>
        </p:nvSpPr>
        <p:spPr>
          <a:xfrm>
            <a:off x="5644341" y="287310"/>
            <a:ext cx="4904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  <p:pic>
        <p:nvPicPr>
          <p:cNvPr id="10" name="Image 9" descr="C:\Users\ledorma191\Documents\THESE\WP2\ACP\MRS 25°C\Global MRS 25 individus.tiff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885410" y="66468"/>
            <a:ext cx="5627717" cy="5677593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Image 10" descr="C:\Users\ledorma191\Documents\THESE\WP2\ACP\MRS25 GLOBAL.ti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7362" y="565201"/>
            <a:ext cx="4916979" cy="4680129"/>
          </a:xfrm>
          <a:prstGeom prst="rect">
            <a:avLst/>
          </a:prstGeom>
          <a:noFill/>
          <a:ln>
            <a:noFill/>
          </a:ln>
        </p:spPr>
      </p:pic>
      <p:sp>
        <p:nvSpPr>
          <p:cNvPr id="2" name="Rectangle 1"/>
          <p:cNvSpPr/>
          <p:nvPr/>
        </p:nvSpPr>
        <p:spPr>
          <a:xfrm>
            <a:off x="857595" y="5544898"/>
            <a:ext cx="10554393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</a:t>
            </a:r>
            <a:r>
              <a:rPr lang="en-US" sz="14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2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: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(A) Principal Component Analysis of the studied compounds (black arrows) with illustrative variables representing the four strains of the model (red arrows). (B) Distribution of the samples in condition C (control), D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(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out phages) and P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(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phages) for all times at 25°C. Samples are named as follows: Condition (C: control, D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out phages, P: </a:t>
            </a:r>
            <a:r>
              <a:rPr lang="en-US" sz="14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disturbance </a:t>
            </a:r>
            <a:r>
              <a:rPr lang="en-US" sz="1400" dirty="0">
                <a:latin typeface="Times New Roman" panose="02020603050405020304" pitchFamily="18" charset="0"/>
                <a:ea typeface="Calibri" panose="020F0502020204030204" pitchFamily="34" charset="0"/>
              </a:rPr>
              <a:t>with phages). Time point (0, 48h, 72h, 96h, 168h). Biological replicate (1, 2, 3) (e.g. C48_1 means Control at 48h, biological replicate 1).</a:t>
            </a:r>
            <a:endParaRPr lang="fr-FR" sz="1400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93226" y="664955"/>
            <a:ext cx="5610060" cy="43891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3188806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24</Words>
  <Application>Microsoft Office PowerPoint</Application>
  <PresentationFormat>Grand écran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_x000d_
			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 Ledormand</dc:creator>
  <cp:lastModifiedBy>Pierre Ledormand</cp:lastModifiedBy>
  <cp:revision>9</cp:revision>
  <dcterms:created xsi:type="dcterms:W3CDTF">2022-07-22T12:25:17Z</dcterms:created>
  <dcterms:modified xsi:type="dcterms:W3CDTF">2022-10-10T14:15:35Z</dcterms:modified>
</cp:coreProperties>
</file>